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olors1.xml" ContentType="application/vnd.ms-office.chartcolorstyle+xml"/>
  <Override PartName="/ppt/charts/style1.xml" ContentType="application/vnd.ms-office.chartstyle+xml"/>
  <Override PartName="/ppt/drawings/drawing1.xml" ContentType="application/vnd.openxmlformats-officedocument.drawingml.chartshap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3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59" autoAdjust="0"/>
    <p:restoredTop sz="94660"/>
  </p:normalViewPr>
  <p:slideViewPr>
    <p:cSldViewPr snapToGrid="0">
      <p:cViewPr>
        <p:scale>
          <a:sx n="60" d="100"/>
          <a:sy n="60" d="100"/>
        </p:scale>
        <p:origin x="756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niceday\Desktop\16RT&#25991;&#31456;\HR\&#25968;&#25454;\&#26524;&#30382;+&#26524;&#32905;-&#33258;&#28982;&#31181;&#36136;&#40644;&#28919;&#37230;&#31958;&#33527;&#22788;&#29702;&#25968;&#25454;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C:\Users\niceday\Desktop\16RT&#25991;&#31456;\HR\&#25968;&#25454;\34&#31181;&#36136;&#20195;&#3587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4821661924954"/>
          <c:y val="0.125012238048478"/>
          <c:w val="0.883587229558225"/>
          <c:h val="0.656068134788097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Flavanone rutinoside</c:f>
              <c:strCache>
                <c:ptCount val="1"/>
                <c:pt idx="0">
                  <c:v>Flavanone rutinoside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</c:spPr>
          <c:invertIfNegative val="0"/>
          <c:dLbls>
            <c:delete val="1"/>
          </c:dLbls>
          <c:cat>
            <c:strRef>
              <c:f>总表!$A$5:$A$47</c:f>
              <c:strCache>
                <c:ptCount val="43"/>
                <c:pt idx="0">
                  <c:v>HRQC</c:v>
                </c:pt>
                <c:pt idx="1">
                  <c:v>HAL</c:v>
                </c:pt>
                <c:pt idx="2">
                  <c:v>TLK</c:v>
                </c:pt>
                <c:pt idx="3">
                  <c:v>FLX</c:v>
                </c:pt>
                <c:pt idx="4">
                  <c:v>QJQC</c:v>
                </c:pt>
                <c:pt idx="5">
                  <c:v>HSD</c:v>
                </c:pt>
                <c:pt idx="6">
                  <c:v>AL</c:v>
                </c:pt>
                <c:pt idx="7">
                  <c:v>NHE</c:v>
                </c:pt>
                <c:pt idx="9">
                  <c:v>NRH</c:v>
                </c:pt>
                <c:pt idx="10">
                  <c:v>NF</c:v>
                </c:pt>
                <c:pt idx="11">
                  <c:v>FAIRC</c:v>
                </c:pt>
                <c:pt idx="12">
                  <c:v>ZHJ</c:v>
                </c:pt>
                <c:pt idx="13">
                  <c:v>GQ</c:v>
                </c:pt>
                <c:pt idx="14">
                  <c:v>QJPG</c:v>
                </c:pt>
                <c:pt idx="15">
                  <c:v>BDZ</c:v>
                </c:pt>
                <c:pt idx="16">
                  <c:v>KLMD</c:v>
                </c:pt>
                <c:pt idx="17">
                  <c:v>HJ</c:v>
                </c:pt>
                <c:pt idx="19">
                  <c:v>LAIM</c:v>
                </c:pt>
                <c:pt idx="20">
                  <c:v>LIM</c:v>
                </c:pt>
                <c:pt idx="21">
                  <c:v>YLK</c:v>
                </c:pt>
                <c:pt idx="22">
                  <c:v>CNM</c:v>
                </c:pt>
                <c:pt idx="23">
                  <c:v>FS</c:v>
                </c:pt>
                <c:pt idx="25">
                  <c:v>YCC</c:v>
                </c:pt>
                <c:pt idx="27">
                  <c:v>ZK</c:v>
                </c:pt>
                <c:pt idx="28">
                  <c:v>ZY</c:v>
                </c:pt>
                <c:pt idx="29">
                  <c:v>ZC</c:v>
                </c:pt>
                <c:pt idx="31">
                  <c:v>XNB</c:v>
                </c:pt>
                <c:pt idx="32">
                  <c:v>JW</c:v>
                </c:pt>
                <c:pt idx="33">
                  <c:v>MX</c:v>
                </c:pt>
                <c:pt idx="34">
                  <c:v>HMX</c:v>
                </c:pt>
                <c:pt idx="36">
                  <c:v>FC</c:v>
                </c:pt>
                <c:pt idx="37">
                  <c:v>HB</c:v>
                </c:pt>
                <c:pt idx="38">
                  <c:v>CH</c:v>
                </c:pt>
                <c:pt idx="39">
                  <c:v>GX</c:v>
                </c:pt>
                <c:pt idx="40">
                  <c:v>ST</c:v>
                </c:pt>
                <c:pt idx="42">
                  <c:v>JG</c:v>
                </c:pt>
              </c:strCache>
            </c:strRef>
          </c:cat>
          <c:val>
            <c:numRef>
              <c:f>总表!$AH$5:$AH$47</c:f>
              <c:numCache>
                <c:formatCode>0.00;[Red]0.00</c:formatCode>
                <c:ptCount val="43"/>
                <c:pt idx="0">
                  <c:v>38.1946723693217</c:v>
                </c:pt>
                <c:pt idx="1">
                  <c:v>34.7787903792494</c:v>
                </c:pt>
                <c:pt idx="2" c:formatCode="0.00_);[Red]\(0.00\)">
                  <c:v>33.1217809565292</c:v>
                </c:pt>
                <c:pt idx="3">
                  <c:v>32.3159134362437</c:v>
                </c:pt>
                <c:pt idx="4" c:formatCode="0.00_);[Red]\(0.00\)">
                  <c:v>32.1606222916081</c:v>
                </c:pt>
                <c:pt idx="5">
                  <c:v>28.3696071208688</c:v>
                </c:pt>
                <c:pt idx="6">
                  <c:v>25.7514836972868</c:v>
                </c:pt>
                <c:pt idx="7">
                  <c:v>17.2354303465619</c:v>
                </c:pt>
                <c:pt idx="9">
                  <c:v>35.4236091583284</c:v>
                </c:pt>
                <c:pt idx="10">
                  <c:v>25.4943868575974</c:v>
                </c:pt>
                <c:pt idx="11">
                  <c:v>27.183351866347</c:v>
                </c:pt>
                <c:pt idx="12">
                  <c:v>23.2589393585102</c:v>
                </c:pt>
                <c:pt idx="13">
                  <c:v>27.0351351729617</c:v>
                </c:pt>
                <c:pt idx="14">
                  <c:v>18.3022554181151</c:v>
                </c:pt>
                <c:pt idx="15">
                  <c:v>12.2873054712258</c:v>
                </c:pt>
                <c:pt idx="16">
                  <c:v>12.0458825420912</c:v>
                </c:pt>
                <c:pt idx="17">
                  <c:v>10.4286636874096</c:v>
                </c:pt>
                <c:pt idx="19">
                  <c:v>13.7335360825764</c:v>
                </c:pt>
                <c:pt idx="20">
                  <c:v>11.6245203813369</c:v>
                </c:pt>
                <c:pt idx="21">
                  <c:v>15.9245948462025</c:v>
                </c:pt>
                <c:pt idx="22">
                  <c:v>3.27816827813746</c:v>
                </c:pt>
                <c:pt idx="23">
                  <c:v>1.91157886512922</c:v>
                </c:pt>
                <c:pt idx="25">
                  <c:v>8.72888901668933</c:v>
                </c:pt>
                <c:pt idx="27">
                  <c:v>3.77494768948251</c:v>
                </c:pt>
                <c:pt idx="28">
                  <c:v>0.415145278835584</c:v>
                </c:pt>
                <c:pt idx="29">
                  <c:v>2.04841728377485</c:v>
                </c:pt>
                <c:pt idx="31">
                  <c:v>6.62431758720478</c:v>
                </c:pt>
                <c:pt idx="32">
                  <c:v>4.90131927307119</c:v>
                </c:pt>
                <c:pt idx="33">
                  <c:v>6.33201025769323</c:v>
                </c:pt>
                <c:pt idx="34">
                  <c:v>8.66730299919138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</c:numCache>
            </c:numRef>
          </c:val>
        </c:ser>
        <c:ser>
          <c:idx val="1"/>
          <c:order val="1"/>
          <c:tx>
            <c:strRef>
              <c:f>Flavanone neohesperidoside</c:f>
              <c:strCache>
                <c:ptCount val="1"/>
                <c:pt idx="0">
                  <c:v>Flavanone neohesperidosid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dLbls>
            <c:delete val="1"/>
          </c:dLbls>
          <c:cat>
            <c:strRef>
              <c:f>总表!$A$5:$A$47</c:f>
              <c:strCache>
                <c:ptCount val="43"/>
                <c:pt idx="0">
                  <c:v>HRQC</c:v>
                </c:pt>
                <c:pt idx="1">
                  <c:v>HAL</c:v>
                </c:pt>
                <c:pt idx="2">
                  <c:v>TLK</c:v>
                </c:pt>
                <c:pt idx="3">
                  <c:v>FLX</c:v>
                </c:pt>
                <c:pt idx="4">
                  <c:v>QJQC</c:v>
                </c:pt>
                <c:pt idx="5">
                  <c:v>HSD</c:v>
                </c:pt>
                <c:pt idx="6">
                  <c:v>AL</c:v>
                </c:pt>
                <c:pt idx="7">
                  <c:v>NHE</c:v>
                </c:pt>
                <c:pt idx="9">
                  <c:v>NRH</c:v>
                </c:pt>
                <c:pt idx="10">
                  <c:v>NF</c:v>
                </c:pt>
                <c:pt idx="11">
                  <c:v>FAIRC</c:v>
                </c:pt>
                <c:pt idx="12">
                  <c:v>ZHJ</c:v>
                </c:pt>
                <c:pt idx="13">
                  <c:v>GQ</c:v>
                </c:pt>
                <c:pt idx="14">
                  <c:v>QJPG</c:v>
                </c:pt>
                <c:pt idx="15">
                  <c:v>BDZ</c:v>
                </c:pt>
                <c:pt idx="16">
                  <c:v>KLMD</c:v>
                </c:pt>
                <c:pt idx="17">
                  <c:v>HJ</c:v>
                </c:pt>
                <c:pt idx="19">
                  <c:v>LAIM</c:v>
                </c:pt>
                <c:pt idx="20">
                  <c:v>LIM</c:v>
                </c:pt>
                <c:pt idx="21">
                  <c:v>YLK</c:v>
                </c:pt>
                <c:pt idx="22">
                  <c:v>CNM</c:v>
                </c:pt>
                <c:pt idx="23">
                  <c:v>FS</c:v>
                </c:pt>
                <c:pt idx="25">
                  <c:v>YCC</c:v>
                </c:pt>
                <c:pt idx="27">
                  <c:v>ZK</c:v>
                </c:pt>
                <c:pt idx="28">
                  <c:v>ZY</c:v>
                </c:pt>
                <c:pt idx="29">
                  <c:v>ZC</c:v>
                </c:pt>
                <c:pt idx="31">
                  <c:v>XNB</c:v>
                </c:pt>
                <c:pt idx="32">
                  <c:v>JW</c:v>
                </c:pt>
                <c:pt idx="33">
                  <c:v>MX</c:v>
                </c:pt>
                <c:pt idx="34">
                  <c:v>HMX</c:v>
                </c:pt>
                <c:pt idx="36">
                  <c:v>FC</c:v>
                </c:pt>
                <c:pt idx="37">
                  <c:v>HB</c:v>
                </c:pt>
                <c:pt idx="38">
                  <c:v>CH</c:v>
                </c:pt>
                <c:pt idx="39">
                  <c:v>GX</c:v>
                </c:pt>
                <c:pt idx="40">
                  <c:v>ST</c:v>
                </c:pt>
                <c:pt idx="42">
                  <c:v>JG</c:v>
                </c:pt>
              </c:strCache>
            </c:strRef>
          </c:cat>
          <c:val>
            <c:numRef>
              <c:f>总表!$AL$5:$AL$47</c:f>
              <c:numCache>
                <c:formatCode>0.00;[Red]0.00</c:formatCode>
                <c:ptCount val="4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5">
                  <c:v>10.109342733334</c:v>
                </c:pt>
                <c:pt idx="27">
                  <c:v>15.8727818708825</c:v>
                </c:pt>
                <c:pt idx="28">
                  <c:v>35.2603809659973</c:v>
                </c:pt>
                <c:pt idx="29">
                  <c:v>5.2603960375177</c:v>
                </c:pt>
                <c:pt idx="31">
                  <c:v>58.0395472921904</c:v>
                </c:pt>
                <c:pt idx="32">
                  <c:v>27.6020825542967</c:v>
                </c:pt>
                <c:pt idx="33">
                  <c:v>53.9041264563846</c:v>
                </c:pt>
                <c:pt idx="34">
                  <c:v>105.592805758265</c:v>
                </c:pt>
                <c:pt idx="36">
                  <c:v>0.306568341197875</c:v>
                </c:pt>
                <c:pt idx="37">
                  <c:v>30.0942652146786</c:v>
                </c:pt>
                <c:pt idx="38">
                  <c:v>6.05796578530917</c:v>
                </c:pt>
                <c:pt idx="39" c:formatCode="0.00_ ">
                  <c:v>3.73529711450059</c:v>
                </c:pt>
                <c:pt idx="40" c:formatCode="0.00_ ">
                  <c:v>1.819868003357</c:v>
                </c:pt>
                <c:pt idx="4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100"/>
        <c:axId val="71676288"/>
        <c:axId val="71677824"/>
      </c:barChart>
      <c:catAx>
        <c:axId val="716762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71677824"/>
        <c:crosses val="autoZero"/>
        <c:auto val="1"/>
        <c:lblAlgn val="ctr"/>
        <c:lblOffset val="100"/>
        <c:noMultiLvlLbl val="0"/>
      </c:catAx>
      <c:valAx>
        <c:axId val="71677824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ln w="15875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71676288"/>
        <c:crosses val="autoZero"/>
        <c:crossBetween val="between"/>
        <c:majorUnit val="0.2"/>
      </c:valAx>
    </c:plotArea>
    <c:plotVisOnly val="1"/>
    <c:dispBlanksAs val="gap"/>
    <c:showDLblsOverMax val="0"/>
  </c:chart>
  <c:txPr>
    <a:bodyPr/>
    <a:lstStyle/>
    <a:p>
      <a:pPr>
        <a:defRPr lang="zh-CN"/>
      </a:pPr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0886482939633"/>
          <c:y val="0.135464489333117"/>
          <c:w val="0.876795302220739"/>
          <c:h val="0.764901077497947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Flavanone rutinoside</c:f>
              <c:strCache>
                <c:ptCount val="1"/>
                <c:pt idx="0">
                  <c:v>Flavanone rutinosid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numRef>
              <c:f>Sheet1!$D$5:$D$47</c:f>
              <c:numCache>
                <c:formatCode>General</c:formatCode>
                <c:ptCount val="43"/>
              </c:numCache>
            </c:numRef>
          </c:cat>
          <c:val>
            <c:numRef>
              <c:f>Sheet1!$B$5:$B$47</c:f>
              <c:numCache>
                <c:formatCode>0.00;[Red]0.00</c:formatCode>
                <c:ptCount val="43"/>
                <c:pt idx="0">
                  <c:v>38.1946723693217</c:v>
                </c:pt>
                <c:pt idx="1">
                  <c:v>34.7787903792494</c:v>
                </c:pt>
                <c:pt idx="2" c:formatCode="0.00_);[Red]\(0.00\)">
                  <c:v>33.1217809565292</c:v>
                </c:pt>
                <c:pt idx="3">
                  <c:v>32.3159134362437</c:v>
                </c:pt>
                <c:pt idx="4" c:formatCode="0.00_);[Red]\(0.00\)">
                  <c:v>32.1606222916081</c:v>
                </c:pt>
                <c:pt idx="5">
                  <c:v>28.3696071208688</c:v>
                </c:pt>
                <c:pt idx="6">
                  <c:v>25.7514836972868</c:v>
                </c:pt>
                <c:pt idx="7">
                  <c:v>17.2354303465619</c:v>
                </c:pt>
                <c:pt idx="9">
                  <c:v>35.4236091583284</c:v>
                </c:pt>
                <c:pt idx="10">
                  <c:v>25.4943868575974</c:v>
                </c:pt>
                <c:pt idx="11">
                  <c:v>27.183351866347</c:v>
                </c:pt>
                <c:pt idx="12">
                  <c:v>23.2589393585102</c:v>
                </c:pt>
                <c:pt idx="13">
                  <c:v>27.0351351729617</c:v>
                </c:pt>
                <c:pt idx="14">
                  <c:v>18.3022554181151</c:v>
                </c:pt>
                <c:pt idx="15">
                  <c:v>12.2873054712258</c:v>
                </c:pt>
                <c:pt idx="16">
                  <c:v>12.0458825420912</c:v>
                </c:pt>
                <c:pt idx="17">
                  <c:v>10.4286636874096</c:v>
                </c:pt>
                <c:pt idx="19">
                  <c:v>13.7335360825764</c:v>
                </c:pt>
                <c:pt idx="20">
                  <c:v>11.6245203813369</c:v>
                </c:pt>
                <c:pt idx="21">
                  <c:v>15.9245948462025</c:v>
                </c:pt>
                <c:pt idx="22">
                  <c:v>3.27816827813746</c:v>
                </c:pt>
                <c:pt idx="23">
                  <c:v>1.91157886512922</c:v>
                </c:pt>
                <c:pt idx="25">
                  <c:v>8.72888901668933</c:v>
                </c:pt>
                <c:pt idx="27">
                  <c:v>3.77494768948251</c:v>
                </c:pt>
                <c:pt idx="28">
                  <c:v>0.415145278835584</c:v>
                </c:pt>
                <c:pt idx="29">
                  <c:v>2.04841728377485</c:v>
                </c:pt>
                <c:pt idx="31">
                  <c:v>6.62431758720478</c:v>
                </c:pt>
                <c:pt idx="32">
                  <c:v>4.90131927307119</c:v>
                </c:pt>
                <c:pt idx="33">
                  <c:v>6.33201025769323</c:v>
                </c:pt>
                <c:pt idx="34">
                  <c:v>8.66730299919138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</c:numCache>
            </c:numRef>
          </c:val>
        </c:ser>
        <c:ser>
          <c:idx val="1"/>
          <c:order val="1"/>
          <c:tx>
            <c:strRef>
              <c:f>Flavanone neohesperidoside</c:f>
              <c:strCache>
                <c:ptCount val="1"/>
                <c:pt idx="0">
                  <c:v>Flavanone neohesperidosid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numRef>
              <c:f>Sheet1!$D$5:$D$47</c:f>
              <c:numCache>
                <c:formatCode>General</c:formatCode>
                <c:ptCount val="43"/>
              </c:numCache>
            </c:numRef>
          </c:cat>
          <c:val>
            <c:numRef>
              <c:f>Sheet1!$C$5:$C$47</c:f>
              <c:numCache>
                <c:formatCode>0.00;[Red]0.00</c:formatCode>
                <c:ptCount val="4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5">
                  <c:v>10.109342733334</c:v>
                </c:pt>
                <c:pt idx="27">
                  <c:v>15.8727818708825</c:v>
                </c:pt>
                <c:pt idx="28">
                  <c:v>35.2603809659973</c:v>
                </c:pt>
                <c:pt idx="29">
                  <c:v>5.2603960375177</c:v>
                </c:pt>
                <c:pt idx="31">
                  <c:v>58.0395472921904</c:v>
                </c:pt>
                <c:pt idx="32">
                  <c:v>27.6020825542967</c:v>
                </c:pt>
                <c:pt idx="33">
                  <c:v>53.9041264563846</c:v>
                </c:pt>
                <c:pt idx="34">
                  <c:v>105.592805758265</c:v>
                </c:pt>
                <c:pt idx="36">
                  <c:v>0.306568341197875</c:v>
                </c:pt>
                <c:pt idx="37">
                  <c:v>30.0942652146786</c:v>
                </c:pt>
                <c:pt idx="38">
                  <c:v>6.05796578530917</c:v>
                </c:pt>
                <c:pt idx="39" c:formatCode="0.00_ ">
                  <c:v>3.73529711450059</c:v>
                </c:pt>
                <c:pt idx="40" c:formatCode="0.00_ ">
                  <c:v>1.819868003357</c:v>
                </c:pt>
                <c:pt idx="4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100"/>
        <c:axId val="476998672"/>
        <c:axId val="476999088"/>
      </c:barChart>
      <c:catAx>
        <c:axId val="476998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solidFill>
            <a:schemeClr val="bg1"/>
          </a:solidFill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476999088"/>
        <c:crosses val="autoZero"/>
        <c:auto val="1"/>
        <c:lblAlgn val="ctr"/>
        <c:lblOffset val="100"/>
        <c:noMultiLvlLbl val="0"/>
      </c:catAx>
      <c:valAx>
        <c:axId val="476999088"/>
        <c:scaling>
          <c:orientation val="minMax"/>
          <c:max val="120"/>
          <c:min val="0"/>
        </c:scaling>
        <c:delete val="0"/>
        <c:axPos val="l"/>
        <c:numFmt formatCode="0.00;[Red]0.00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</a:p>
        </c:txPr>
        <c:crossAx val="4769986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546187715941976"/>
          <c:y val="0.0165408142964733"/>
          <c:w val="0.452566205526034"/>
          <c:h val="0.09362062751864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16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0826</cdr:x>
      <cdr:y>0.50794</cdr:y>
    </cdr:from>
    <cdr:to>
      <cdr:x>0.03651</cdr:x>
      <cdr:y>0.86517</cdr:y>
    </cdr:to>
    <cdr:sp>
      <cdr:nvSpPr>
        <cdr:cNvPr id="2" name="矩形 1"/>
        <cdr:cNvSpPr/>
      </cdr:nvSpPr>
      <cdr:spPr xmlns:a="http://schemas.openxmlformats.org/drawingml/2006/main">
        <a:xfrm xmlns:a="http://schemas.openxmlformats.org/drawingml/2006/main" rot="16200000">
          <a:off x="56520" y="1219200"/>
          <a:ext cx="193193" cy="857463"/>
        </a:xfrm>
        <a:prstGeom xmlns:a="http://schemas.openxmlformats.org/drawingml/2006/main" prst="rect">
          <a:avLst/>
        </a:prstGeom>
      </cdr:spPr>
      <cdr:txBody xmlns:a="http://schemas.openxmlformats.org/drawingml/2006/main">
        <a:bodyPr vert="horz" wrap="none" lIns="45720" tIns="45720" rIns="45720" bIns="45720" rtlCol="0" anchor="t" anchorCtr="0">
          <a:normAutofit/>
        </a:bodyPr>
        <a:lstStyle>
          <a:lvl1pPr marL="0" indent="0">
            <a:defRPr sz="1100">
              <a:latin typeface="Calibri" panose="020F0502020204030204"/>
            </a:defRPr>
          </a:lvl1pPr>
          <a:lvl2pPr marL="457200" indent="0">
            <a:defRPr sz="1100">
              <a:latin typeface="Calibri" panose="020F0502020204030204"/>
            </a:defRPr>
          </a:lvl2pPr>
          <a:lvl3pPr marL="914400" indent="0">
            <a:defRPr sz="1100">
              <a:latin typeface="Calibri" panose="020F0502020204030204"/>
            </a:defRPr>
          </a:lvl3pPr>
          <a:lvl4pPr marL="1371600" indent="0">
            <a:defRPr sz="1100">
              <a:latin typeface="Calibri" panose="020F0502020204030204"/>
            </a:defRPr>
          </a:lvl4pPr>
          <a:lvl5pPr marL="1828800" indent="0">
            <a:defRPr sz="1100">
              <a:latin typeface="Calibri" panose="020F0502020204030204"/>
            </a:defRPr>
          </a:lvl5pPr>
          <a:lvl6pPr marL="2286000" indent="0">
            <a:defRPr sz="1100">
              <a:latin typeface="Calibri" panose="020F0502020204030204"/>
            </a:defRPr>
          </a:lvl6pPr>
          <a:lvl7pPr marL="2743200" indent="0">
            <a:defRPr sz="1100">
              <a:latin typeface="Calibri" panose="020F0502020204030204"/>
            </a:defRPr>
          </a:lvl7pPr>
          <a:lvl8pPr marL="3200400" indent="0">
            <a:defRPr sz="1100">
              <a:latin typeface="Calibri" panose="020F0502020204030204"/>
            </a:defRPr>
          </a:lvl8pPr>
          <a:lvl9pPr marL="3657600" indent="0">
            <a:defRPr sz="1100">
              <a:latin typeface="Calibri" panose="020F0502020204030204"/>
            </a:defRPr>
          </a:lvl9pPr>
        </a:lstStyle>
        <a:p>
          <a:endParaRPr lang="zh-CN" alt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</cdr:x>
      <cdr:y>0</cdr:y>
    </cdr:from>
    <cdr:to>
      <cdr:x>0.04596</cdr:x>
      <cdr:y>0.11508</cdr:y>
    </cdr:to>
    <cdr:sp>
      <cdr:nvSpPr>
        <cdr:cNvPr id="3" name="矩形 2"/>
        <cdr:cNvSpPr/>
      </cdr:nvSpPr>
      <cdr:spPr xmlns:a="http://schemas.openxmlformats.org/drawingml/2006/main">
        <a:xfrm xmlns:a="http://schemas.openxmlformats.org/drawingml/2006/main">
          <a:off x="0" y="0"/>
          <a:ext cx="314326" cy="276225"/>
        </a:xfrm>
        <a:prstGeom xmlns:a="http://schemas.openxmlformats.org/drawingml/2006/main" prst="rect">
          <a:avLst/>
        </a:prstGeom>
      </cdr:spPr>
      <cdr:txBody xmlns:a="http://schemas.openxmlformats.org/drawingml/2006/main">
        <a:bodyPr vert="horz" wrap="none" lIns="45720" tIns="45720" rIns="45720" bIns="45720" rtlCol="0" anchor="t" anchorCtr="0">
          <a:normAutofit/>
        </a:bodyPr>
        <a:lstStyle>
          <a:lvl1pPr marL="0" indent="0">
            <a:defRPr sz="1100">
              <a:latin typeface="Calibri" panose="020F0502020204030204"/>
            </a:defRPr>
          </a:lvl1pPr>
          <a:lvl2pPr marL="457200" indent="0">
            <a:defRPr sz="1100">
              <a:latin typeface="Calibri" panose="020F0502020204030204"/>
            </a:defRPr>
          </a:lvl2pPr>
          <a:lvl3pPr marL="914400" indent="0">
            <a:defRPr sz="1100">
              <a:latin typeface="Calibri" panose="020F0502020204030204"/>
            </a:defRPr>
          </a:lvl3pPr>
          <a:lvl4pPr marL="1371600" indent="0">
            <a:defRPr sz="1100">
              <a:latin typeface="Calibri" panose="020F0502020204030204"/>
            </a:defRPr>
          </a:lvl4pPr>
          <a:lvl5pPr marL="1828800" indent="0">
            <a:defRPr sz="1100">
              <a:latin typeface="Calibri" panose="020F0502020204030204"/>
            </a:defRPr>
          </a:lvl5pPr>
          <a:lvl6pPr marL="2286000" indent="0">
            <a:defRPr sz="1100">
              <a:latin typeface="Calibri" panose="020F0502020204030204"/>
            </a:defRPr>
          </a:lvl6pPr>
          <a:lvl7pPr marL="2743200" indent="0">
            <a:defRPr sz="1100">
              <a:latin typeface="Calibri" panose="020F0502020204030204"/>
            </a:defRPr>
          </a:lvl7pPr>
          <a:lvl8pPr marL="3200400" indent="0">
            <a:defRPr sz="1100">
              <a:latin typeface="Calibri" panose="020F0502020204030204"/>
            </a:defRPr>
          </a:lvl8pPr>
          <a:lvl9pPr marL="3657600" indent="0">
            <a:defRPr sz="1100">
              <a:latin typeface="Calibri" panose="020F0502020204030204"/>
            </a:defRPr>
          </a:lvl9pPr>
        </a:lstStyle>
        <a:p>
          <a:endParaRPr lang="zh-CN" altLang="en-US" sz="120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B8E69B-6F6A-476D-963D-2B51424C38D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13D535-C661-4866-A581-8618C4ABFB4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5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1" y="274639"/>
            <a:ext cx="8070575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5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76672" cy="452596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05728" y="1600201"/>
            <a:ext cx="5376672" cy="452596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5" y="1778438"/>
            <a:ext cx="4873575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5"/>
            </a:lvl4pPr>
            <a:lvl5pPr marL="1371600" indent="0">
              <a:buNone/>
              <a:defRPr sz="1355"/>
            </a:lvl5pPr>
            <a:lvl6pPr marL="1714500" indent="0">
              <a:buNone/>
              <a:defRPr sz="1355"/>
            </a:lvl6pPr>
            <a:lvl7pPr marL="2057400" indent="0">
              <a:buNone/>
              <a:defRPr sz="1355"/>
            </a:lvl7pPr>
            <a:lvl8pPr marL="2400300" indent="0">
              <a:buNone/>
              <a:defRPr sz="1355"/>
            </a:lvl8pPr>
            <a:lvl9pPr marL="2743200" indent="0">
              <a:buNone/>
              <a:defRPr sz="135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5" y="2665379"/>
            <a:ext cx="4873575" cy="35242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40" y="1778438"/>
            <a:ext cx="4897577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5"/>
            </a:lvl4pPr>
            <a:lvl5pPr marL="1371600" indent="0">
              <a:buNone/>
              <a:defRPr sz="1355"/>
            </a:lvl5pPr>
            <a:lvl6pPr marL="1714500" indent="0">
              <a:buNone/>
              <a:defRPr sz="1355"/>
            </a:lvl6pPr>
            <a:lvl7pPr marL="2057400" indent="0">
              <a:buNone/>
              <a:defRPr sz="1355"/>
            </a:lvl7pPr>
            <a:lvl8pPr marL="2400300" indent="0">
              <a:buNone/>
              <a:defRPr sz="1355"/>
            </a:lvl8pPr>
            <a:lvl9pPr marL="2743200" indent="0">
              <a:buNone/>
              <a:defRPr sz="135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40" y="2665379"/>
            <a:ext cx="4897577" cy="35242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9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9" y="987426"/>
            <a:ext cx="6172201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9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5"/>
            </a:lvl2pPr>
            <a:lvl3pPr marL="685800" indent="0">
              <a:buNone/>
              <a:defRPr sz="900"/>
            </a:lvl3pPr>
            <a:lvl4pPr marL="1028700" indent="0">
              <a:buNone/>
              <a:defRPr sz="755"/>
            </a:lvl4pPr>
            <a:lvl5pPr marL="1371600" indent="0">
              <a:buNone/>
              <a:defRPr sz="755"/>
            </a:lvl5pPr>
            <a:lvl6pPr marL="1714500" indent="0">
              <a:buNone/>
              <a:defRPr sz="755"/>
            </a:lvl6pPr>
            <a:lvl7pPr marL="2057400" indent="0">
              <a:buNone/>
              <a:defRPr sz="755"/>
            </a:lvl7pPr>
            <a:lvl8pPr marL="2400300" indent="0">
              <a:buNone/>
              <a:defRPr sz="755"/>
            </a:lvl8pPr>
            <a:lvl9pPr marL="2743200" indent="0">
              <a:buNone/>
              <a:defRPr sz="75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9" y="457201"/>
            <a:ext cx="6172201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5"/>
            </a:lvl2pPr>
            <a:lvl3pPr marL="685800" indent="0">
              <a:buNone/>
              <a:defRPr sz="1200"/>
            </a:lvl3pPr>
            <a:lvl4pPr marL="1028700" indent="0">
              <a:buNone/>
              <a:defRPr sz="1055"/>
            </a:lvl4pPr>
            <a:lvl5pPr marL="1371600" indent="0">
              <a:buNone/>
              <a:defRPr sz="1055"/>
            </a:lvl5pPr>
            <a:lvl6pPr marL="1714500" indent="0">
              <a:buNone/>
              <a:defRPr sz="1055"/>
            </a:lvl6pPr>
            <a:lvl7pPr marL="2057400" indent="0">
              <a:buNone/>
              <a:defRPr sz="1055"/>
            </a:lvl7pPr>
            <a:lvl8pPr marL="2400300" indent="0">
              <a:buNone/>
              <a:defRPr sz="1055"/>
            </a:lvl8pPr>
            <a:lvl9pPr marL="2743200" indent="0">
              <a:buNone/>
              <a:defRPr sz="105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10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文本占位符 1026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/>
            <a:fld id="{9A0DB2DC-4C9A-4742-B13C-FB6460FD3503}" type="slidenum">
              <a:rPr lang="zh-CN" altLang="en-US">
                <a:latin typeface="Arial" panose="020B0604020202020204" pitchFamily="34" charset="0"/>
              </a:rPr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3585" lvl="1" indent="-285115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chart" Target="../charts/chart2.xml"/><Relationship Id="rId1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图表 8"/>
          <p:cNvGraphicFramePr/>
          <p:nvPr/>
        </p:nvGraphicFramePr>
        <p:xfrm>
          <a:off x="830451" y="2654612"/>
          <a:ext cx="10121245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12" name="图表 11"/>
          <p:cNvGraphicFramePr/>
          <p:nvPr/>
        </p:nvGraphicFramePr>
        <p:xfrm>
          <a:off x="759722" y="129560"/>
          <a:ext cx="10191974" cy="30620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4" name="直接连接符 13"/>
          <p:cNvCxnSpPr/>
          <p:nvPr/>
        </p:nvCxnSpPr>
        <p:spPr>
          <a:xfrm>
            <a:off x="1929656" y="5822998"/>
            <a:ext cx="1628707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2508031" y="5812750"/>
            <a:ext cx="226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>
            <a:off x="3811619" y="5822998"/>
            <a:ext cx="1774018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4639266" y="5812750"/>
            <a:ext cx="226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5891073" y="5812750"/>
            <a:ext cx="956294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6260922" y="5812750"/>
            <a:ext cx="226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7113817" y="5822998"/>
            <a:ext cx="165941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7052930" y="5812750"/>
            <a:ext cx="226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/>
          <p:cNvCxnSpPr/>
          <p:nvPr/>
        </p:nvCxnSpPr>
        <p:spPr>
          <a:xfrm>
            <a:off x="7524943" y="5822998"/>
            <a:ext cx="591243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7645518" y="5812750"/>
            <a:ext cx="226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8379092" y="5822998"/>
            <a:ext cx="771996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8592605" y="5822998"/>
            <a:ext cx="226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/>
          <p:cNvCxnSpPr/>
          <p:nvPr/>
        </p:nvCxnSpPr>
        <p:spPr>
          <a:xfrm>
            <a:off x="9417539" y="5822998"/>
            <a:ext cx="974014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9791132" y="5812750"/>
            <a:ext cx="226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/>
          <p:cNvCxnSpPr/>
          <p:nvPr/>
        </p:nvCxnSpPr>
        <p:spPr>
          <a:xfrm>
            <a:off x="10636738" y="5822998"/>
            <a:ext cx="194295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10587528" y="5812750"/>
            <a:ext cx="226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接连接符 41"/>
          <p:cNvCxnSpPr/>
          <p:nvPr/>
        </p:nvCxnSpPr>
        <p:spPr>
          <a:xfrm flipV="1">
            <a:off x="6989061" y="580135"/>
            <a:ext cx="0" cy="4791487"/>
          </a:xfrm>
          <a:prstGeom prst="line">
            <a:avLst/>
          </a:prstGeom>
          <a:ln w="158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>
            <a:off x="4021105" y="539496"/>
            <a:ext cx="12175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Ⅰ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7521856" y="580135"/>
            <a:ext cx="12175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Ⅱ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9651024" y="539496"/>
            <a:ext cx="12175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 Ⅲ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/>
          <p:cNvCxnSpPr/>
          <p:nvPr/>
        </p:nvCxnSpPr>
        <p:spPr>
          <a:xfrm flipV="1">
            <a:off x="9272232" y="539496"/>
            <a:ext cx="0" cy="4791487"/>
          </a:xfrm>
          <a:prstGeom prst="line">
            <a:avLst/>
          </a:prstGeom>
          <a:ln w="158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/>
          <p:cNvCxnSpPr/>
          <p:nvPr/>
        </p:nvCxnSpPr>
        <p:spPr>
          <a:xfrm flipV="1">
            <a:off x="10831033" y="580535"/>
            <a:ext cx="0" cy="4791487"/>
          </a:xfrm>
          <a:prstGeom prst="line">
            <a:avLst/>
          </a:prstGeom>
          <a:ln w="158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 rot="10800000">
            <a:off x="1040249" y="3634537"/>
            <a:ext cx="400110" cy="163119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content (%)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866168" y="2654612"/>
            <a:ext cx="348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黑体" panose="02010609060101010101" pitchFamily="49" charset="-122"/>
                <a:ea typeface="黑体" panose="02010609060101010101" pitchFamily="49" charset="-122"/>
              </a:rPr>
              <a:t>b</a:t>
            </a:r>
            <a:endParaRPr lang="zh-CN" altLang="en-US" sz="2400" b="1" dirty="0">
              <a:latin typeface="黑体" panose="02010609060101010101" pitchFamily="49" charset="-122"/>
              <a:ea typeface="黑体" panose="02010609060101010101" pitchFamily="49" charset="-122"/>
            </a:endParaRPr>
          </a:p>
        </p:txBody>
      </p:sp>
      <p:sp>
        <p:nvSpPr>
          <p:cNvPr id="59" name="文本框 58"/>
          <p:cNvSpPr txBox="1"/>
          <p:nvPr/>
        </p:nvSpPr>
        <p:spPr>
          <a:xfrm rot="10800000">
            <a:off x="1040249" y="635376"/>
            <a:ext cx="400110" cy="185468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>
            <a:defPPr>
              <a:defRPr lang="zh-CN"/>
            </a:defPPr>
            <a:lvl1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Content (mg/</a:t>
            </a:r>
            <a:r>
              <a:rPr lang="en-US" altLang="zh-CN" dirty="0" err="1"/>
              <a:t>g.DW</a:t>
            </a:r>
            <a:r>
              <a:rPr lang="en-US" altLang="zh-CN" dirty="0"/>
              <a:t>)</a:t>
            </a:r>
            <a:endParaRPr lang="en-US" altLang="zh-CN" dirty="0"/>
          </a:p>
        </p:txBody>
      </p:sp>
      <p:sp>
        <p:nvSpPr>
          <p:cNvPr id="60" name="文本框 59"/>
          <p:cNvSpPr txBox="1"/>
          <p:nvPr/>
        </p:nvSpPr>
        <p:spPr>
          <a:xfrm>
            <a:off x="866168" y="-75391"/>
            <a:ext cx="348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黑体" panose="02010609060101010101" pitchFamily="49" charset="-122"/>
                <a:ea typeface="黑体" panose="02010609060101010101" pitchFamily="49" charset="-122"/>
              </a:rPr>
              <a:t>a</a:t>
            </a:r>
            <a:endParaRPr lang="zh-CN" altLang="en-US" sz="2400" b="1" dirty="0">
              <a:latin typeface="黑体" panose="02010609060101010101" pitchFamily="49" charset="-122"/>
              <a:ea typeface="黑体" panose="02010609060101010101" pitchFamily="49" charset="-122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WPS 演示</Application>
  <PresentationFormat>宽屏</PresentationFormat>
  <Paragraphs>3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Times New Roman</vt:lpstr>
      <vt:lpstr>Calibri</vt:lpstr>
      <vt:lpstr>黑体</vt:lpstr>
      <vt:lpstr>等线</vt:lpstr>
      <vt:lpstr>微软雅黑</vt:lpstr>
      <vt:lpstr>Arial Unicode MS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古</dc:creator>
  <cp:lastModifiedBy>李东西</cp:lastModifiedBy>
  <cp:revision>26</cp:revision>
  <dcterms:created xsi:type="dcterms:W3CDTF">2021-01-13T13:36:00Z</dcterms:created>
  <dcterms:modified xsi:type="dcterms:W3CDTF">2021-03-11T05:49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92</vt:lpwstr>
  </property>
</Properties>
</file>